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8"/>
    <p:restoredTop sz="96208"/>
  </p:normalViewPr>
  <p:slideViewPr>
    <p:cSldViewPr snapToGrid="0" snapToObjects="1">
      <p:cViewPr varScale="1">
        <p:scale>
          <a:sx n="116" d="100"/>
          <a:sy n="116" d="100"/>
        </p:scale>
        <p:origin x="200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726B6-D9B1-1842-A79C-C9848F5225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D7A378-A86D-A746-B0DF-DCB3BCDCD2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FDA0FC-698B-4842-BB4F-7C2DB91F4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F8506A-B5B4-4448-A163-1F8A350BA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5058E-1ECC-4040-AFF0-772B31B8E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269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22219-C9E9-8744-8C36-9C33AE2713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B45592-CD16-B34F-A939-523255443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C3F29-567B-1240-99DA-55E4E134C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D5E913-02E6-614C-B4B2-7D5D112DFC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7C6213-1A84-9D49-836C-A2DF63370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DCA92C-4CE2-A243-AC23-9796B8EA98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A666F1-66FD-C543-8A09-9DEDB685C9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1EC3D-74BE-4144-B6CB-4A4A91B15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50C28-3D7E-AC4B-A219-EFAF29E66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8E8EE2-4057-DC49-83D5-29221FE56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29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85071-6B1D-3D4B-B02A-55C165006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9BD47D-F355-534E-9590-51E3440DA1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A703F7-1FD9-CE45-AE35-14F954D4D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F69B32-EDB4-6E45-914E-FBC2CABFE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6C9F31-3005-8C46-ADFC-65A6A98BC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233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E7087-C6C6-D542-BEA1-28600CA975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440700-98DE-6542-841C-A110B4C44D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F6D0F8-9DD6-4C40-9175-0543992A9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C81EE9-3163-A643-863A-624E45926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BD02A3-E901-A94B-A748-50E3EE088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337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3973E-F5F5-134C-953A-91BD382AF6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47A4F5-4542-2247-8032-3B177F6AF1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B6E93C-EEAA-EE41-9720-19B53E9B4C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89966E-7424-F44A-9D0D-58AB91F6E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E951DE-BA08-8C44-AC91-556BA5A16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27DF6A-06F7-4445-8452-F1B7106A6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256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D6BD6-D78D-CE47-AF42-573D01B59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5E94F6-2A16-7A4B-8713-BBD17E87D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8651CF-CD65-0E41-B1B3-5D370B34DD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C6CD2A-8866-AD47-8DCD-19B31F7131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0FB338-4F87-B341-BF28-5096F12BF0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DDFF50-D5E7-6849-ADE3-FE861F191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94D90D-A933-3C4B-8DEF-B35DFB00B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2AEF65-174D-0D49-A617-5BB8D774F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004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5ED3B-D2FD-7041-9461-31E1C73E3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799F21-85BA-D845-AC02-4ED615523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20D717-C646-2E4B-BA05-4860A9CA7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363EE9-8094-3D40-A327-CBC175D82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75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63F70F-ACC5-FD44-A1C2-2C31103AB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96A740-9452-DE45-817D-4C389F8D5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A92F35-06D6-E945-BFEC-DA06AA016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03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0846A-3C9E-2C43-9536-9A2397313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ED542F-E494-684D-BF08-153B7C3496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8B199C-AB44-3044-88F3-C08FFCE3CD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C095DD-7044-1E4F-A157-063E1300B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1E422F-95A5-3247-A750-EC80AF589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20DE69-4F98-AE40-8333-9B2B9F48A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383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9A8C3-7AEB-6F46-9885-255DB31E5D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DF7798-65A1-C945-B15E-53B12AD1EF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EF31A2-E46A-8F42-8D55-9B97A13B8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8F1343-5807-FD4C-9451-63E8E878B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DB05BC-FD80-2D49-BB7E-F23F7AD11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9EC9AA-F162-FF4B-8C16-7AB820092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235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CA7C9F-85FE-8647-AFCE-5DA8B59EF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F4E213-4C2A-3E45-AC4D-5B0AFB546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816B85-995C-4C4E-B244-58F6ECA454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A753C-410D-B140-BD2E-D782DC50080F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466930-266E-7542-ACD6-A5DC4A4101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86FC60-2A0D-CA41-A30C-847A89E8D9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E75A7-6CFD-804B-9368-E75B77AB00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207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9F4F87-EE92-A748-9934-B59815ED45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056" y="1496460"/>
            <a:ext cx="5029200" cy="50292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0317FF6-60B3-3B48-B082-A5C19886D1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1677" y="1496460"/>
            <a:ext cx="5029200" cy="50292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F7A9916-911D-BE4F-9AAA-CAB4FD6C3BDD}"/>
              </a:ext>
            </a:extLst>
          </p:cNvPr>
          <p:cNvSpPr/>
          <p:nvPr/>
        </p:nvSpPr>
        <p:spPr>
          <a:xfrm>
            <a:off x="217487" y="70452"/>
            <a:ext cx="110032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2</a:t>
            </a:r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(A) Adjusted overall survival by race and (B) adjusted progression-free survival by race.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357A493-BE85-D542-A927-A652BB285E05}"/>
              </a:ext>
            </a:extLst>
          </p:cNvPr>
          <p:cNvSpPr/>
          <p:nvPr/>
        </p:nvSpPr>
        <p:spPr>
          <a:xfrm>
            <a:off x="164615" y="1236404"/>
            <a:ext cx="6988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endParaRPr lang="en-US" sz="2000" i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3CC4380-EB4B-364C-B114-19D862387F74}"/>
              </a:ext>
            </a:extLst>
          </p:cNvPr>
          <p:cNvSpPr/>
          <p:nvPr/>
        </p:nvSpPr>
        <p:spPr>
          <a:xfrm>
            <a:off x="6022259" y="1236403"/>
            <a:ext cx="6988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endParaRPr lang="en-US" sz="2000" i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0951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ran, Thomas</dc:creator>
  <cp:lastModifiedBy>Curran, Thomas</cp:lastModifiedBy>
  <cp:revision>2</cp:revision>
  <dcterms:created xsi:type="dcterms:W3CDTF">2020-10-03T03:35:42Z</dcterms:created>
  <dcterms:modified xsi:type="dcterms:W3CDTF">2020-10-25T21:04:54Z</dcterms:modified>
</cp:coreProperties>
</file>